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353"/>
    <p:restoredTop sz="94741"/>
  </p:normalViewPr>
  <p:slideViewPr>
    <p:cSldViewPr snapToGrid="0" snapToObjects="1">
      <p:cViewPr varScale="1">
        <p:scale>
          <a:sx n="94" d="100"/>
          <a:sy n="94" d="100"/>
        </p:scale>
        <p:origin x="100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317086-9C5B-3145-8873-C6935EFE27E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7339D05-CD52-4343-B766-C3AFB17DF48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7257EB9-39F6-7640-BDB0-8C1FE8AE9F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F4ED8-2821-ED48-9D89-6D3B4C112793}" type="datetimeFigureOut">
              <a:rPr lang="en-US" smtClean="0"/>
              <a:t>7/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986F25-4AC0-A54A-AC6A-AAA5F383FB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E6F543-00C3-6F4F-BED8-73F53D3734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062A2-CB2D-D644-8F1B-1F19575076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37886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104747-74FE-6D4C-9AC5-3D6772D328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C8F7080-96ED-0441-B90F-8844BD72251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38C808-4AE2-0045-831F-2DA91ACDD3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F4ED8-2821-ED48-9D89-6D3B4C112793}" type="datetimeFigureOut">
              <a:rPr lang="en-US" smtClean="0"/>
              <a:t>7/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3BDF1B-E75D-A84B-81B2-865B1A8FF6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58191C-8BCA-9041-AEB1-1CE91E6A2B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062A2-CB2D-D644-8F1B-1F19575076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44391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FA99821-ECB6-E947-ADC2-F817FAFB06F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08669FF-AD63-A044-9DDC-551A5E76F55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D4EBCF-2ACC-1748-B76C-72C0E2FD92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F4ED8-2821-ED48-9D89-6D3B4C112793}" type="datetimeFigureOut">
              <a:rPr lang="en-US" smtClean="0"/>
              <a:t>7/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B94912-05A2-2A41-963C-3BC3F42640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676426-D674-5145-A660-5E91319AA7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062A2-CB2D-D644-8F1B-1F19575076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01134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BC29CB-5B10-CD47-AB9C-529F563814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0BBDFDF-B32D-E14D-A9DD-F776C5EE7A9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A5F67A-C5EE-3844-9DCF-7FE7CFACB7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F4ED8-2821-ED48-9D89-6D3B4C112793}" type="datetimeFigureOut">
              <a:rPr lang="en-US" smtClean="0"/>
              <a:t>7/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9AE730-916A-2E4D-8D6D-F0B3C9BA92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3B6757-C19E-7C44-8066-6B72FEC382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062A2-CB2D-D644-8F1B-1F19575076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24719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8047A6-77D8-E642-8E6D-893931D4CF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C48FCAF-AFA8-1446-B8AA-D120395660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AB2DF7-A182-E44B-944C-558150E067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F4ED8-2821-ED48-9D89-6D3B4C112793}" type="datetimeFigureOut">
              <a:rPr lang="en-US" smtClean="0"/>
              <a:t>7/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07CE79-F2CB-B345-9022-1FB37F39FE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E07784-3396-2B40-9CF8-9007FCD876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062A2-CB2D-D644-8F1B-1F19575076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34883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997CBE-A01D-074B-BEC6-8279B7F6C5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B2351FB-2623-CE4A-8199-952ACF2F0CE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10B4085-AEFB-E746-9B07-35AB7E32AD2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8FAD99E-DF4E-9140-A896-0FCB8F53ED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F4ED8-2821-ED48-9D89-6D3B4C112793}" type="datetimeFigureOut">
              <a:rPr lang="en-US" smtClean="0"/>
              <a:t>7/1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CC39C88-B664-AF41-92B2-3300779587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AB94CC-1AE7-BB40-9526-321C8E8175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062A2-CB2D-D644-8F1B-1F19575076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86542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F1B5AC-26AE-374D-9773-D822B514EE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F61D3EF-58C6-384E-B7D7-FE9C05589E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9049F5C-5556-3840-953D-12CAA18F169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5ABC617-A375-8B40-8424-03D12A347CA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ADC2D2F-E95C-314D-A4C9-5C66C35A03B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8E1C885-016C-7046-8316-92D744ED45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F4ED8-2821-ED48-9D89-6D3B4C112793}" type="datetimeFigureOut">
              <a:rPr lang="en-US" smtClean="0"/>
              <a:t>7/1/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24DDE2E-693F-B949-B120-39E296E983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B1614FB-2400-8F47-8FA3-70433B1C4F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062A2-CB2D-D644-8F1B-1F19575076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58313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09E97D-419B-3840-846B-ECE35B4633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2340BC4-4B6E-464C-ABF3-886A7E5490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F4ED8-2821-ED48-9D89-6D3B4C112793}" type="datetimeFigureOut">
              <a:rPr lang="en-US" smtClean="0"/>
              <a:t>7/1/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BEAD1A1-BDE2-1741-B504-1E23BA5A69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B6167E4-F722-314B-8C0F-AFF36E0A5D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062A2-CB2D-D644-8F1B-1F19575076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96941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BE47046-903F-6D49-A24D-D036644586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F4ED8-2821-ED48-9D89-6D3B4C112793}" type="datetimeFigureOut">
              <a:rPr lang="en-US" smtClean="0"/>
              <a:t>7/1/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70C425E-5D86-DE45-9E7E-9A42217DDA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C7ECA38-495C-F248-A5A5-AFBFD44036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062A2-CB2D-D644-8F1B-1F19575076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05780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140F54-1701-564B-85DD-EDB353AA7E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EB1CB98-6BA8-1F48-B40D-07D76C715D3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E5F66C9-D6FD-BC47-A651-D333FBBCE56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CB87D15-4EBC-1249-B441-A91C7FD26B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F4ED8-2821-ED48-9D89-6D3B4C112793}" type="datetimeFigureOut">
              <a:rPr lang="en-US" smtClean="0"/>
              <a:t>7/1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EF4DD1D-BD28-BC45-B17C-E9B5A0D5B6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664C2F7-8938-2843-BD2D-61DD2F664F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062A2-CB2D-D644-8F1B-1F19575076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66322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C5D0B7-C3FE-9441-A176-4638F68443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A4D8126-0B42-0648-82AE-C1AA32B15EA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B7E0EDA-CF24-704E-85E3-0B2C6668ACF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C76F3B1-6012-5846-A85F-C6923A4D88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F4ED8-2821-ED48-9D89-6D3B4C112793}" type="datetimeFigureOut">
              <a:rPr lang="en-US" smtClean="0"/>
              <a:t>7/1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A242373-4564-024D-BF3F-7C94E94B7C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130D85F-6EA4-364D-A67B-FE711FDFEF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2062A2-CB2D-D644-8F1B-1F19575076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50343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4F741AB-3C80-A640-B7F1-6160E9ADB4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9EC94FD-0E9F-3249-92E0-01E2068F88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B24E0E-BEB0-B54E-95DB-96EBD8D0C40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AF4ED8-2821-ED48-9D89-6D3B4C112793}" type="datetimeFigureOut">
              <a:rPr lang="en-US" smtClean="0"/>
              <a:t>7/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367E4E-F52D-854B-AD92-EF86327E4C8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1F3650-DDEF-7E42-8E7E-9D382B6CBC4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2062A2-CB2D-D644-8F1B-1F19575076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82254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E422B8A1-D6F6-9848-9919-44171F6928BC}"/>
              </a:ext>
            </a:extLst>
          </p:cNvPr>
          <p:cNvGrpSpPr/>
          <p:nvPr/>
        </p:nvGrpSpPr>
        <p:grpSpPr>
          <a:xfrm>
            <a:off x="118800" y="0"/>
            <a:ext cx="11617283" cy="5939254"/>
            <a:chOff x="118800" y="0"/>
            <a:chExt cx="11617283" cy="5939254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5FF84F1A-95E6-0B4A-B150-939B51E6BE9D}"/>
                </a:ext>
              </a:extLst>
            </p:cNvPr>
            <p:cNvPicPr/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8800" y="360794"/>
              <a:ext cx="7560310" cy="4358640"/>
            </a:xfrm>
            <a:prstGeom prst="rect">
              <a:avLst/>
            </a:prstGeom>
            <a:noFill/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89B5D5D0-B038-7B42-B3FF-06921F35E230}"/>
                </a:ext>
              </a:extLst>
            </p:cNvPr>
            <p:cNvSpPr txBox="1"/>
            <p:nvPr/>
          </p:nvSpPr>
          <p:spPr>
            <a:xfrm>
              <a:off x="202810" y="0"/>
              <a:ext cx="19383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upplementary Figure 1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9E574454-33F3-C948-B9B3-0594CC92FB24}"/>
                </a:ext>
              </a:extLst>
            </p:cNvPr>
            <p:cNvSpPr txBox="1"/>
            <p:nvPr/>
          </p:nvSpPr>
          <p:spPr>
            <a:xfrm>
              <a:off x="118800" y="4831258"/>
              <a:ext cx="11617283" cy="1107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Gating strategy for identification of T cells and NK cells in blood (top) and </a:t>
              </a:r>
              <a:r>
                <a:rPr lang="en-US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tumour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(bottom) samples.</a:t>
              </a:r>
            </a:p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For blood, mononuclear cells were isolated on a </a:t>
              </a:r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Ficoll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gradient and for </a:t>
              </a:r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tumour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samples, single cell suspensions were generated using mechanical disruption. Cells were stained</a:t>
              </a:r>
            </a:p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with appropriate antibodies and  lymphocytes identified using forward and side scatter (FSC, SSC). Live cells in the lymphocyte gate were identified using a dead cell discriminator.</a:t>
              </a:r>
            </a:p>
            <a:p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Haematopoietic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cells were identified via staining with anti-CD45 antibodies and CD45+ cells were then </a:t>
              </a:r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analysed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for NK cells (NKp46+CD3negative) and T cells (NKp46negativeCD3+).</a:t>
              </a:r>
            </a:p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Note that NKp46 was used to identify NK cells in place of CD56 as many cells in the brain express the CD56 molecule. </a:t>
              </a:r>
            </a:p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These NK cell and T cell gates were used to determine the expression of PD-1, NKG2D </a:t>
              </a:r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etc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as shown in the main text.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6473359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4</TotalTime>
  <Words>162</Words>
  <Application>Microsoft Macintosh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5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raham Cook</dc:creator>
  <cp:lastModifiedBy>Erica Watson</cp:lastModifiedBy>
  <cp:revision>8</cp:revision>
  <dcterms:created xsi:type="dcterms:W3CDTF">2018-07-17T15:17:29Z</dcterms:created>
  <dcterms:modified xsi:type="dcterms:W3CDTF">2019-07-01T12:01:17Z</dcterms:modified>
</cp:coreProperties>
</file>